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s-A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D2269"/>
    <a:srgbClr val="A3C512"/>
    <a:srgbClr val="FFCC66"/>
    <a:srgbClr val="558ED5"/>
    <a:srgbClr val="B0E0E6"/>
    <a:srgbClr val="00CED1"/>
    <a:srgbClr val="28622E"/>
    <a:srgbClr val="FFE4E1"/>
    <a:srgbClr val="F08080"/>
    <a:srgbClr val="A5337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514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Julio\Documents\TRABAJOS%20MAC\Trab%20MASA%20microarrays\DATOS%202022\blastKoala%20REVISADO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Julio\Documents\TRABAJOS%20MAC\Trab%20MASA%20microarrays\DATOS%202022\blastKoala%20REVISADO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Julio\Documents\TRABAJOS%20MAC\Trab%20MASA%20microarrays\DATOS%202022\blastKoala%20REVISADO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Hoja1!$B$1</c:f>
              <c:strCache>
                <c:ptCount val="1"/>
                <c:pt idx="0">
                  <c:v>WCFS1</c:v>
                </c:pt>
              </c:strCache>
            </c:strRef>
          </c:tx>
          <c:spPr>
            <a:solidFill>
              <a:srgbClr val="9D2269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Hoja1!$A$26:$A$29</c:f>
              <c:strCache>
                <c:ptCount val="4"/>
                <c:pt idx="0">
                  <c:v>Transport and catabolism</c:v>
                </c:pt>
                <c:pt idx="1">
                  <c:v>Cell growth and death</c:v>
                </c:pt>
                <c:pt idx="2">
                  <c:v>Cellular community - prokaryotes</c:v>
                </c:pt>
                <c:pt idx="3">
                  <c:v>Cell motility</c:v>
                </c:pt>
              </c:strCache>
            </c:strRef>
          </c:cat>
          <c:val>
            <c:numRef>
              <c:f>Hoja1!$B$26:$B$29</c:f>
              <c:numCache>
                <c:formatCode>General</c:formatCode>
                <c:ptCount val="4"/>
                <c:pt idx="0">
                  <c:v>5</c:v>
                </c:pt>
                <c:pt idx="1">
                  <c:v>13</c:v>
                </c:pt>
                <c:pt idx="2">
                  <c:v>42</c:v>
                </c:pt>
                <c:pt idx="3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C4E-4B69-BB4C-EDCF28A51697}"/>
            </c:ext>
          </c:extLst>
        </c:ser>
        <c:ser>
          <c:idx val="1"/>
          <c:order val="1"/>
          <c:tx>
            <c:strRef>
              <c:f>Hoja1!$C$1</c:f>
              <c:strCache>
                <c:ptCount val="1"/>
                <c:pt idx="0">
                  <c:v>CRL1506</c:v>
                </c:pt>
              </c:strCache>
            </c:strRef>
          </c:tx>
          <c:spPr>
            <a:solidFill>
              <a:srgbClr val="FFCC66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Hoja1!$A$26:$A$29</c:f>
              <c:strCache>
                <c:ptCount val="4"/>
                <c:pt idx="0">
                  <c:v>Transport and catabolism</c:v>
                </c:pt>
                <c:pt idx="1">
                  <c:v>Cell growth and death</c:v>
                </c:pt>
                <c:pt idx="2">
                  <c:v>Cellular community - prokaryotes</c:v>
                </c:pt>
                <c:pt idx="3">
                  <c:v>Cell motility</c:v>
                </c:pt>
              </c:strCache>
            </c:strRef>
          </c:cat>
          <c:val>
            <c:numRef>
              <c:f>Hoja1!$C$26:$C$29</c:f>
              <c:numCache>
                <c:formatCode>General</c:formatCode>
                <c:ptCount val="4"/>
                <c:pt idx="0">
                  <c:v>5</c:v>
                </c:pt>
                <c:pt idx="1">
                  <c:v>13</c:v>
                </c:pt>
                <c:pt idx="2">
                  <c:v>43</c:v>
                </c:pt>
                <c:pt idx="3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C4E-4B69-BB4C-EDCF28A51697}"/>
            </c:ext>
          </c:extLst>
        </c:ser>
        <c:ser>
          <c:idx val="2"/>
          <c:order val="2"/>
          <c:tx>
            <c:strRef>
              <c:f>Hoja1!$D$1</c:f>
              <c:strCache>
                <c:ptCount val="1"/>
                <c:pt idx="0">
                  <c:v>LOC1</c:v>
                </c:pt>
              </c:strCache>
            </c:strRef>
          </c:tx>
          <c:spPr>
            <a:solidFill>
              <a:srgbClr val="558ED5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Hoja1!$A$26:$A$29</c:f>
              <c:strCache>
                <c:ptCount val="4"/>
                <c:pt idx="0">
                  <c:v>Transport and catabolism</c:v>
                </c:pt>
                <c:pt idx="1">
                  <c:v>Cell growth and death</c:v>
                </c:pt>
                <c:pt idx="2">
                  <c:v>Cellular community - prokaryotes</c:v>
                </c:pt>
                <c:pt idx="3">
                  <c:v>Cell motility</c:v>
                </c:pt>
              </c:strCache>
            </c:strRef>
          </c:cat>
          <c:val>
            <c:numRef>
              <c:f>Hoja1!$D$26:$D$29</c:f>
              <c:numCache>
                <c:formatCode>General</c:formatCode>
                <c:ptCount val="4"/>
                <c:pt idx="0">
                  <c:v>5</c:v>
                </c:pt>
                <c:pt idx="1">
                  <c:v>13</c:v>
                </c:pt>
                <c:pt idx="2">
                  <c:v>42</c:v>
                </c:pt>
                <c:pt idx="3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C4E-4B69-BB4C-EDCF28A5169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737338847"/>
        <c:axId val="737341343"/>
        <c:extLst>
          <c:ext xmlns:c15="http://schemas.microsoft.com/office/drawing/2012/chart" uri="{02D57815-91ED-43cb-92C2-25804820EDAC}">
            <c15:filteredBarSeries>
              <c15:ser>
                <c:idx val="3"/>
                <c:order val="3"/>
                <c:tx>
                  <c:strRef>
                    <c:extLst>
                      <c:ext uri="{02D57815-91ED-43cb-92C2-25804820EDAC}">
                        <c15:formulaRef>
                          <c15:sqref>Hoja1!#REF!</c15:sqref>
                        </c15:formulaRef>
                      </c:ext>
                    </c:extLst>
                    <c:strCache>
                      <c:ptCount val="1"/>
                      <c:pt idx="0">
                        <c:v>#REF!</c:v>
                      </c:pt>
                    </c:strCache>
                  </c:strRef>
                </c:tx>
                <c:spPr>
                  <a:solidFill>
                    <a:srgbClr val="FFE4E1"/>
                  </a:solidFill>
                  <a:ln>
                    <a:solidFill>
                      <a:schemeClr val="tx1"/>
                    </a:solidFill>
                  </a:ln>
                  <a:effectLst/>
                </c:spPr>
                <c:invertIfNegative val="0"/>
                <c:cat>
                  <c:strRef>
                    <c:extLst>
                      <c:ext uri="{02D57815-91ED-43cb-92C2-25804820EDAC}">
                        <c15:formulaRef>
                          <c15:sqref>Hoja1!$A$26:$A$29</c15:sqref>
                        </c15:formulaRef>
                      </c:ext>
                    </c:extLst>
                    <c:strCache>
                      <c:ptCount val="4"/>
                      <c:pt idx="0">
                        <c:v>Transport and catabolism</c:v>
                      </c:pt>
                      <c:pt idx="1">
                        <c:v>Cell growth and death</c:v>
                      </c:pt>
                      <c:pt idx="2">
                        <c:v>Cellular community - prokaryotes</c:v>
                      </c:pt>
                      <c:pt idx="3">
                        <c:v>Cell motility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Hoja1!#REF!</c15:sqref>
                        </c15:formulaRef>
                      </c:ext>
                    </c:extLst>
                    <c:numCache>
                      <c:formatCode>General</c:formatCode>
                      <c:ptCount val="1"/>
                      <c:pt idx="0">
                        <c:v>1</c:v>
                      </c:pt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3-7C4E-4B69-BB4C-EDCF28A51697}"/>
                  </c:ext>
                </c:extLst>
              </c15:ser>
            </c15:filteredBarSeries>
            <c15:filteredBarSeries>
              <c15:ser>
                <c:idx val="4"/>
                <c:order val="4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Hoja1!#REF!</c15:sqref>
                        </c15:formulaRef>
                      </c:ext>
                    </c:extLst>
                    <c:strCache>
                      <c:ptCount val="1"/>
                      <c:pt idx="0">
                        <c:v>#REF!</c:v>
                      </c:pt>
                    </c:strCache>
                  </c:strRef>
                </c:tx>
                <c:spPr>
                  <a:solidFill>
                    <a:srgbClr val="F08080"/>
                  </a:solidFill>
                  <a:ln>
                    <a:solidFill>
                      <a:schemeClr val="tx1"/>
                    </a:solidFill>
                  </a:ln>
                  <a:effectLst/>
                </c:spPr>
                <c:invertIfNegative val="0"/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Hoja1!$A$26:$A$29</c15:sqref>
                        </c15:formulaRef>
                      </c:ext>
                    </c:extLst>
                    <c:strCache>
                      <c:ptCount val="4"/>
                      <c:pt idx="0">
                        <c:v>Transport and catabolism</c:v>
                      </c:pt>
                      <c:pt idx="1">
                        <c:v>Cell growth and death</c:v>
                      </c:pt>
                      <c:pt idx="2">
                        <c:v>Cellular community - prokaryotes</c:v>
                      </c:pt>
                      <c:pt idx="3">
                        <c:v>Cell motility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Hoja1!#REF!</c15:sqref>
                        </c15:formulaRef>
                      </c:ext>
                    </c:extLst>
                    <c:numCache>
                      <c:formatCode>General</c:formatCode>
                      <c:ptCount val="1"/>
                      <c:pt idx="0">
                        <c:v>1</c:v>
                      </c:pt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4-7C4E-4B69-BB4C-EDCF28A51697}"/>
                  </c:ext>
                </c:extLst>
              </c15:ser>
            </c15:filteredBarSeries>
          </c:ext>
        </c:extLst>
      </c:barChart>
      <c:catAx>
        <c:axId val="737338847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s-AR"/>
          </a:p>
        </c:txPr>
        <c:crossAx val="737341343"/>
        <c:crosses val="autoZero"/>
        <c:auto val="1"/>
        <c:lblAlgn val="ctr"/>
        <c:lblOffset val="100"/>
        <c:noMultiLvlLbl val="0"/>
      </c:catAx>
      <c:valAx>
        <c:axId val="737341343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s-AR"/>
          </a:p>
        </c:txPr>
        <c:crossAx val="73733884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s-A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Hoja1!$B$1</c:f>
              <c:strCache>
                <c:ptCount val="1"/>
                <c:pt idx="0">
                  <c:v>WCFS1</c:v>
                </c:pt>
              </c:strCache>
            </c:strRef>
          </c:tx>
          <c:spPr>
            <a:solidFill>
              <a:srgbClr val="9D2269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Hoja1!$A$15:$A$18</c:f>
              <c:strCache>
                <c:ptCount val="4"/>
                <c:pt idx="0">
                  <c:v>Translation</c:v>
                </c:pt>
                <c:pt idx="1">
                  <c:v>Replication and repair</c:v>
                </c:pt>
                <c:pt idx="2">
                  <c:v>Folding, sorting and degradation</c:v>
                </c:pt>
                <c:pt idx="3">
                  <c:v>Transcription</c:v>
                </c:pt>
              </c:strCache>
            </c:strRef>
          </c:cat>
          <c:val>
            <c:numRef>
              <c:f>Hoja1!$B$15:$B$18</c:f>
              <c:numCache>
                <c:formatCode>General</c:formatCode>
                <c:ptCount val="4"/>
                <c:pt idx="0">
                  <c:v>80</c:v>
                </c:pt>
                <c:pt idx="1">
                  <c:v>69</c:v>
                </c:pt>
                <c:pt idx="2">
                  <c:v>31</c:v>
                </c:pt>
                <c:pt idx="3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0DC-4BBA-A90C-AE2A51627728}"/>
            </c:ext>
          </c:extLst>
        </c:ser>
        <c:ser>
          <c:idx val="1"/>
          <c:order val="1"/>
          <c:tx>
            <c:strRef>
              <c:f>Hoja1!$C$1</c:f>
              <c:strCache>
                <c:ptCount val="1"/>
                <c:pt idx="0">
                  <c:v>CRL1506</c:v>
                </c:pt>
              </c:strCache>
            </c:strRef>
          </c:tx>
          <c:spPr>
            <a:solidFill>
              <a:srgbClr val="FFCC66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Hoja1!$A$15:$A$18</c:f>
              <c:strCache>
                <c:ptCount val="4"/>
                <c:pt idx="0">
                  <c:v>Translation</c:v>
                </c:pt>
                <c:pt idx="1">
                  <c:v>Replication and repair</c:v>
                </c:pt>
                <c:pt idx="2">
                  <c:v>Folding, sorting and degradation</c:v>
                </c:pt>
                <c:pt idx="3">
                  <c:v>Transcription</c:v>
                </c:pt>
              </c:strCache>
            </c:strRef>
          </c:cat>
          <c:val>
            <c:numRef>
              <c:f>Hoja1!$C$15:$C$18</c:f>
              <c:numCache>
                <c:formatCode>General</c:formatCode>
                <c:ptCount val="4"/>
                <c:pt idx="0">
                  <c:v>77</c:v>
                </c:pt>
                <c:pt idx="1">
                  <c:v>69</c:v>
                </c:pt>
                <c:pt idx="2">
                  <c:v>25</c:v>
                </c:pt>
                <c:pt idx="3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0DC-4BBA-A90C-AE2A51627728}"/>
            </c:ext>
          </c:extLst>
        </c:ser>
        <c:ser>
          <c:idx val="2"/>
          <c:order val="2"/>
          <c:tx>
            <c:strRef>
              <c:f>Hoja1!$D$1</c:f>
              <c:strCache>
                <c:ptCount val="1"/>
                <c:pt idx="0">
                  <c:v>LOC1</c:v>
                </c:pt>
              </c:strCache>
            </c:strRef>
          </c:tx>
          <c:spPr>
            <a:solidFill>
              <a:srgbClr val="558ED5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Hoja1!$A$15:$A$18</c:f>
              <c:strCache>
                <c:ptCount val="4"/>
                <c:pt idx="0">
                  <c:v>Translation</c:v>
                </c:pt>
                <c:pt idx="1">
                  <c:v>Replication and repair</c:v>
                </c:pt>
                <c:pt idx="2">
                  <c:v>Folding, sorting and degradation</c:v>
                </c:pt>
                <c:pt idx="3">
                  <c:v>Transcription</c:v>
                </c:pt>
              </c:strCache>
            </c:strRef>
          </c:cat>
          <c:val>
            <c:numRef>
              <c:f>Hoja1!$D$15:$D$18</c:f>
              <c:numCache>
                <c:formatCode>General</c:formatCode>
                <c:ptCount val="4"/>
                <c:pt idx="0">
                  <c:v>78</c:v>
                </c:pt>
                <c:pt idx="1">
                  <c:v>68</c:v>
                </c:pt>
                <c:pt idx="2">
                  <c:v>25</c:v>
                </c:pt>
                <c:pt idx="3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0DC-4BBA-A90C-AE2A5162772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737338847"/>
        <c:axId val="737341343"/>
      </c:barChart>
      <c:catAx>
        <c:axId val="737338847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s-AR"/>
          </a:p>
        </c:txPr>
        <c:crossAx val="737341343"/>
        <c:crosses val="autoZero"/>
        <c:auto val="1"/>
        <c:lblAlgn val="ctr"/>
        <c:lblOffset val="100"/>
        <c:noMultiLvlLbl val="0"/>
      </c:catAx>
      <c:valAx>
        <c:axId val="737341343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s-AR"/>
          </a:p>
        </c:txPr>
        <c:crossAx val="73733884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s-A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Hoja1!$B$1</c:f>
              <c:strCache>
                <c:ptCount val="1"/>
                <c:pt idx="0">
                  <c:v>WCFS1</c:v>
                </c:pt>
              </c:strCache>
            </c:strRef>
          </c:tx>
          <c:spPr>
            <a:solidFill>
              <a:srgbClr val="9D2269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Hoja1!$A$21:$A$23</c:f>
              <c:strCache>
                <c:ptCount val="3"/>
                <c:pt idx="0">
                  <c:v>Membrane transport</c:v>
                </c:pt>
                <c:pt idx="1">
                  <c:v>Signal transduction</c:v>
                </c:pt>
                <c:pt idx="2">
                  <c:v>Signaling molecules and interaction</c:v>
                </c:pt>
              </c:strCache>
            </c:strRef>
          </c:cat>
          <c:val>
            <c:numRef>
              <c:f>Hoja1!$B$21:$B$23</c:f>
              <c:numCache>
                <c:formatCode>General</c:formatCode>
                <c:ptCount val="3"/>
                <c:pt idx="0">
                  <c:v>118</c:v>
                </c:pt>
                <c:pt idx="1">
                  <c:v>57</c:v>
                </c:pt>
                <c:pt idx="2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D08-4516-B6DA-4C0150D7DA89}"/>
            </c:ext>
          </c:extLst>
        </c:ser>
        <c:ser>
          <c:idx val="1"/>
          <c:order val="1"/>
          <c:tx>
            <c:strRef>
              <c:f>Hoja1!$C$1</c:f>
              <c:strCache>
                <c:ptCount val="1"/>
                <c:pt idx="0">
                  <c:v>CRL1506</c:v>
                </c:pt>
              </c:strCache>
            </c:strRef>
          </c:tx>
          <c:spPr>
            <a:solidFill>
              <a:srgbClr val="FFCC66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Hoja1!$A$21:$A$23</c:f>
              <c:strCache>
                <c:ptCount val="3"/>
                <c:pt idx="0">
                  <c:v>Membrane transport</c:v>
                </c:pt>
                <c:pt idx="1">
                  <c:v>Signal transduction</c:v>
                </c:pt>
                <c:pt idx="2">
                  <c:v>Signaling molecules and interaction</c:v>
                </c:pt>
              </c:strCache>
            </c:strRef>
          </c:cat>
          <c:val>
            <c:numRef>
              <c:f>Hoja1!$C$21:$C$23</c:f>
              <c:numCache>
                <c:formatCode>General</c:formatCode>
                <c:ptCount val="3"/>
                <c:pt idx="0">
                  <c:v>125</c:v>
                </c:pt>
                <c:pt idx="1">
                  <c:v>51</c:v>
                </c:pt>
                <c:pt idx="2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D08-4516-B6DA-4C0150D7DA89}"/>
            </c:ext>
          </c:extLst>
        </c:ser>
        <c:ser>
          <c:idx val="2"/>
          <c:order val="2"/>
          <c:tx>
            <c:strRef>
              <c:f>Hoja1!$D$1</c:f>
              <c:strCache>
                <c:ptCount val="1"/>
                <c:pt idx="0">
                  <c:v>LOC1</c:v>
                </c:pt>
              </c:strCache>
            </c:strRef>
          </c:tx>
          <c:spPr>
            <a:solidFill>
              <a:srgbClr val="558ED5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Hoja1!$A$21:$A$23</c:f>
              <c:strCache>
                <c:ptCount val="3"/>
                <c:pt idx="0">
                  <c:v>Membrane transport</c:v>
                </c:pt>
                <c:pt idx="1">
                  <c:v>Signal transduction</c:v>
                </c:pt>
                <c:pt idx="2">
                  <c:v>Signaling molecules and interaction</c:v>
                </c:pt>
              </c:strCache>
            </c:strRef>
          </c:cat>
          <c:val>
            <c:numRef>
              <c:f>Hoja1!$D$21:$D$23</c:f>
              <c:numCache>
                <c:formatCode>General</c:formatCode>
                <c:ptCount val="3"/>
                <c:pt idx="0">
                  <c:v>122</c:v>
                </c:pt>
                <c:pt idx="1">
                  <c:v>49</c:v>
                </c:pt>
                <c:pt idx="2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D08-4516-B6DA-4C0150D7DA8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737338847"/>
        <c:axId val="737341343"/>
        <c:extLst>
          <c:ext xmlns:c15="http://schemas.microsoft.com/office/drawing/2012/chart" uri="{02D57815-91ED-43cb-92C2-25804820EDAC}">
            <c15:filteredBarSeries>
              <c15:ser>
                <c:idx val="3"/>
                <c:order val="3"/>
                <c:tx>
                  <c:strRef>
                    <c:extLst>
                      <c:ext uri="{02D57815-91ED-43cb-92C2-25804820EDAC}">
                        <c15:formulaRef>
                          <c15:sqref>Hoja1!#REF!</c15:sqref>
                        </c15:formulaRef>
                      </c:ext>
                    </c:extLst>
                    <c:strCache>
                      <c:ptCount val="1"/>
                      <c:pt idx="0">
                        <c:v>#REF!</c:v>
                      </c:pt>
                    </c:strCache>
                  </c:strRef>
                </c:tx>
                <c:spPr>
                  <a:solidFill>
                    <a:srgbClr val="FFE4E1"/>
                  </a:solidFill>
                  <a:ln>
                    <a:solidFill>
                      <a:schemeClr val="tx1"/>
                    </a:solidFill>
                  </a:ln>
                  <a:effectLst/>
                </c:spPr>
                <c:invertIfNegative val="0"/>
                <c:cat>
                  <c:strRef>
                    <c:extLst>
                      <c:ext uri="{02D57815-91ED-43cb-92C2-25804820EDAC}">
                        <c15:formulaRef>
                          <c15:sqref>Hoja1!$A$21:$A$23</c15:sqref>
                        </c15:formulaRef>
                      </c:ext>
                    </c:extLst>
                    <c:strCache>
                      <c:ptCount val="3"/>
                      <c:pt idx="0">
                        <c:v>Membrane transport</c:v>
                      </c:pt>
                      <c:pt idx="1">
                        <c:v>Signal transduction</c:v>
                      </c:pt>
                      <c:pt idx="2">
                        <c:v>Signaling molecules and interaction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Hoja1!#REF!</c15:sqref>
                        </c15:formulaRef>
                      </c:ext>
                    </c:extLst>
                    <c:numCache>
                      <c:formatCode>General</c:formatCode>
                      <c:ptCount val="1"/>
                      <c:pt idx="0">
                        <c:v>1</c:v>
                      </c:pt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3-ED08-4516-B6DA-4C0150D7DA89}"/>
                  </c:ext>
                </c:extLst>
              </c15:ser>
            </c15:filteredBarSeries>
            <c15:filteredBarSeries>
              <c15:ser>
                <c:idx val="4"/>
                <c:order val="4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Hoja1!#REF!</c15:sqref>
                        </c15:formulaRef>
                      </c:ext>
                    </c:extLst>
                    <c:strCache>
                      <c:ptCount val="1"/>
                      <c:pt idx="0">
                        <c:v>#REF!</c:v>
                      </c:pt>
                    </c:strCache>
                  </c:strRef>
                </c:tx>
                <c:spPr>
                  <a:solidFill>
                    <a:srgbClr val="F08080"/>
                  </a:solidFill>
                  <a:ln>
                    <a:solidFill>
                      <a:schemeClr val="tx1"/>
                    </a:solidFill>
                  </a:ln>
                  <a:effectLst/>
                </c:spPr>
                <c:invertIfNegative val="0"/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Hoja1!$A$21:$A$23</c15:sqref>
                        </c15:formulaRef>
                      </c:ext>
                    </c:extLst>
                    <c:strCache>
                      <c:ptCount val="3"/>
                      <c:pt idx="0">
                        <c:v>Membrane transport</c:v>
                      </c:pt>
                      <c:pt idx="1">
                        <c:v>Signal transduction</c:v>
                      </c:pt>
                      <c:pt idx="2">
                        <c:v>Signaling molecules and interaction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Hoja1!#REF!</c15:sqref>
                        </c15:formulaRef>
                      </c:ext>
                    </c:extLst>
                    <c:numCache>
                      <c:formatCode>General</c:formatCode>
                      <c:ptCount val="1"/>
                      <c:pt idx="0">
                        <c:v>1</c:v>
                      </c:pt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4-ED08-4516-B6DA-4C0150D7DA89}"/>
                  </c:ext>
                </c:extLst>
              </c15:ser>
            </c15:filteredBarSeries>
          </c:ext>
        </c:extLst>
      </c:barChart>
      <c:catAx>
        <c:axId val="737338847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s-AR"/>
          </a:p>
        </c:txPr>
        <c:crossAx val="737341343"/>
        <c:crosses val="autoZero"/>
        <c:auto val="1"/>
        <c:lblAlgn val="ctr"/>
        <c:lblOffset val="100"/>
        <c:noMultiLvlLbl val="0"/>
      </c:catAx>
      <c:valAx>
        <c:axId val="737341343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s-AR"/>
          </a:p>
        </c:txPr>
        <c:crossAx val="73733884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s-A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713D872-41DB-4260-9C35-2CFB1F4F32E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F9B1F62F-6049-46E4-A6E8-F2F8ECABCC3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AR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DC23923-2F36-4978-9AC0-6F7502E45E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CCBB5-A831-4BA7-A8DA-F4EA0CD92277}" type="datetimeFigureOut">
              <a:rPr lang="es-AR" smtClean="0"/>
              <a:t>29/08/2022</a:t>
            </a:fld>
            <a:endParaRPr lang="es-AR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321C0FF-A719-4090-A61A-D370D88050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F2908C2-85FF-4000-87DD-7C2E68A25A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BEA90-BEAF-451A-8311-EA3BABD446C5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7845561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AF7B458-F858-4A1C-8871-4D59D2F8F3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C5BF9849-64A4-4C99-B070-049367EE4D2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158A34E-FB26-4CB9-8F0F-C2696961DB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CCBB5-A831-4BA7-A8DA-F4EA0CD92277}" type="datetimeFigureOut">
              <a:rPr lang="es-AR" smtClean="0"/>
              <a:t>29/08/2022</a:t>
            </a:fld>
            <a:endParaRPr lang="es-AR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8324B92-6986-47A5-A0D8-58E5528EFE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1588105-36DA-4672-B3B3-5B193EB873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BEA90-BEAF-451A-8311-EA3BABD446C5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9919019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218B9FEE-9ACA-42BC-9813-2500F80261D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9669B97B-5EBF-495F-B792-6244B6D37EE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C7E7282-94A9-4429-B10B-63C2DF8465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CCBB5-A831-4BA7-A8DA-F4EA0CD92277}" type="datetimeFigureOut">
              <a:rPr lang="es-AR" smtClean="0"/>
              <a:t>29/08/2022</a:t>
            </a:fld>
            <a:endParaRPr lang="es-AR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EC1C10B-0E73-48E6-A0F8-19334F0532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F131B99-F3E6-46F8-A7DC-57DD91FEDE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BEA90-BEAF-451A-8311-EA3BABD446C5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3337302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420D4FA-FA05-4E01-9FF9-9E85AEEB05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78A87E21-E125-4820-91C1-B6E7BB357DD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3A85B68-664E-4666-84B2-1F12957B1B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CCBB5-A831-4BA7-A8DA-F4EA0CD92277}" type="datetimeFigureOut">
              <a:rPr lang="es-AR" smtClean="0"/>
              <a:t>29/08/2022</a:t>
            </a:fld>
            <a:endParaRPr lang="es-AR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F478A67-273D-4A76-9F4A-8DD235103A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E27F25D-C7C9-4EEC-BBE8-B6AE27FFFA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BEA90-BEAF-451A-8311-EA3BABD446C5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8837041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DFD425E-85E8-4F25-97C6-9AAB7DE48E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905E655F-B9A4-410E-ADBE-90CC8C3B09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2C18279-B916-4A95-A772-F49F60F69B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CCBB5-A831-4BA7-A8DA-F4EA0CD92277}" type="datetimeFigureOut">
              <a:rPr lang="es-AR" smtClean="0"/>
              <a:t>29/08/2022</a:t>
            </a:fld>
            <a:endParaRPr lang="es-AR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1827002-0001-4A66-B8E5-CFEAAA2472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CB5CF962-273E-4945-B808-6EE8C223D5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BEA90-BEAF-451A-8311-EA3BABD446C5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8188991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AF7EE51-72A4-47F3-88EB-CD186E773B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FEBB484A-7ABA-45A7-847B-FC6B039826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C02A8191-DA1E-430F-911D-AED09A87CF8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43DC26CB-A433-4927-A66A-F1FC9E1DDC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CCBB5-A831-4BA7-A8DA-F4EA0CD92277}" type="datetimeFigureOut">
              <a:rPr lang="es-AR" smtClean="0"/>
              <a:t>29/08/2022</a:t>
            </a:fld>
            <a:endParaRPr lang="es-AR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152A827C-BF71-453B-AB99-036680D56E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D403105E-5409-4717-907E-5D98BB17F1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BEA90-BEAF-451A-8311-EA3BABD446C5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24327774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8A0F307-CF09-4022-8583-CC1090520C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A719C7F2-D67B-43C0-BF3D-2103CB3D2B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C1C65DAF-187F-4B7A-8677-721C45AF15D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2C0A336C-BC34-4280-87DE-79DE48C4F81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C0436760-E394-430C-8281-B64EC2180CB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54F1EA05-42CD-4709-A16F-6A410FE880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CCBB5-A831-4BA7-A8DA-F4EA0CD92277}" type="datetimeFigureOut">
              <a:rPr lang="es-AR" smtClean="0"/>
              <a:t>29/08/2022</a:t>
            </a:fld>
            <a:endParaRPr lang="es-AR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E0006857-4DFE-485B-AEFA-5CA4881BB0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EF6C949B-0427-4C96-94C0-3238666B97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BEA90-BEAF-451A-8311-EA3BABD446C5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21120249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844F43B-8B7B-4A02-AAB3-904C91A6C2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B0F51F45-8E6B-4840-B051-500588B37D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CCBB5-A831-4BA7-A8DA-F4EA0CD92277}" type="datetimeFigureOut">
              <a:rPr lang="es-AR" smtClean="0"/>
              <a:t>29/08/2022</a:t>
            </a:fld>
            <a:endParaRPr lang="es-AR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366164B7-7768-4D0C-8BD3-FC32F13940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77F8C18A-2FCD-4159-80FC-E9E6CD5204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BEA90-BEAF-451A-8311-EA3BABD446C5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8613533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BDE7686E-8781-4D65-8DD0-C3F5F7FF95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CCBB5-A831-4BA7-A8DA-F4EA0CD92277}" type="datetimeFigureOut">
              <a:rPr lang="es-AR" smtClean="0"/>
              <a:t>29/08/2022</a:t>
            </a:fld>
            <a:endParaRPr lang="es-AR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93856598-5092-46AE-B6FE-C0EA0E05E5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9F6267BF-CA64-4D38-982C-99FF24879B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BEA90-BEAF-451A-8311-EA3BABD446C5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8531642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43867B1-2955-40BD-9C91-173A883D09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7694D737-FDB2-48DF-BE59-1867BEB5A84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65AC83A7-92E7-44FF-85B2-64AA033673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6CD3B12E-7E67-4447-BB78-65AD05E97F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CCBB5-A831-4BA7-A8DA-F4EA0CD92277}" type="datetimeFigureOut">
              <a:rPr lang="es-AR" smtClean="0"/>
              <a:t>29/08/2022</a:t>
            </a:fld>
            <a:endParaRPr lang="es-AR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9A707B61-DBB1-4C77-BAA5-86526B7E8C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9B07A8BD-D28E-4AC7-A940-F7F2A1BAE3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BEA90-BEAF-451A-8311-EA3BABD446C5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81181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C06F49B-44BF-4679-B5FA-DD5E2C2FC6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F286D7C9-499E-4A19-89DF-FB4B0D41A9E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AR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B3B11926-6D34-49B2-8287-5A788981B63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E7721094-FA09-482A-B733-0F1A5666B2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CCBB5-A831-4BA7-A8DA-F4EA0CD92277}" type="datetimeFigureOut">
              <a:rPr lang="es-AR" smtClean="0"/>
              <a:t>29/08/2022</a:t>
            </a:fld>
            <a:endParaRPr lang="es-AR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EBCAF2AA-8DE2-4FA2-9E0B-B8273472B2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613D7975-F9BE-4687-A34F-8DC44FFE34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BEA90-BEAF-451A-8311-EA3BABD446C5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22404601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F21D055B-AB8E-4DF6-8976-13DC98DF10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C376C714-9386-4563-8FD9-750B5C1095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3CC89A3-C393-4C37-B4C8-EDD75777405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4CCBB5-A831-4BA7-A8DA-F4EA0CD92277}" type="datetimeFigureOut">
              <a:rPr lang="es-AR" smtClean="0"/>
              <a:t>29/08/2022</a:t>
            </a:fld>
            <a:endParaRPr lang="es-AR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AAC377F-D3DD-4AE3-A400-92D9AC02098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AR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E3343C7-B77F-4FD5-A334-634ED1A601C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8BEA90-BEAF-451A-8311-EA3BABD446C5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5335460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A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áfico 3">
            <a:extLst>
              <a:ext uri="{FF2B5EF4-FFF2-40B4-BE49-F238E27FC236}">
                <a16:creationId xmlns:a16="http://schemas.microsoft.com/office/drawing/2014/main" id="{D275A62D-128D-4AB4-BA79-9D98BB0CADC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54403423"/>
              </p:ext>
            </p:extLst>
          </p:nvPr>
        </p:nvGraphicFramePr>
        <p:xfrm>
          <a:off x="370617" y="3936211"/>
          <a:ext cx="5399999" cy="28253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" name="Gráfico 1">
            <a:extLst>
              <a:ext uri="{FF2B5EF4-FFF2-40B4-BE49-F238E27FC236}">
                <a16:creationId xmlns:a16="http://schemas.microsoft.com/office/drawing/2014/main" id="{C1663B7D-84CA-4BD1-9765-B19D093646F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59003698"/>
              </p:ext>
            </p:extLst>
          </p:nvPr>
        </p:nvGraphicFramePr>
        <p:xfrm>
          <a:off x="241972" y="660319"/>
          <a:ext cx="5400000" cy="28043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" name="Gráfico 2">
            <a:extLst>
              <a:ext uri="{FF2B5EF4-FFF2-40B4-BE49-F238E27FC236}">
                <a16:creationId xmlns:a16="http://schemas.microsoft.com/office/drawing/2014/main" id="{B6E67308-A1E8-41EF-9FAE-CA7A342AE0A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12783246"/>
              </p:ext>
            </p:extLst>
          </p:nvPr>
        </p:nvGraphicFramePr>
        <p:xfrm>
          <a:off x="5770617" y="674636"/>
          <a:ext cx="5400000" cy="27543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" name="CuadroTexto 4">
            <a:extLst>
              <a:ext uri="{FF2B5EF4-FFF2-40B4-BE49-F238E27FC236}">
                <a16:creationId xmlns:a16="http://schemas.microsoft.com/office/drawing/2014/main" id="{968AEE3B-C9F2-8787-C5F5-7CFF47D22185}"/>
              </a:ext>
            </a:extLst>
          </p:cNvPr>
          <p:cNvSpPr txBox="1"/>
          <p:nvPr/>
        </p:nvSpPr>
        <p:spPr>
          <a:xfrm>
            <a:off x="1933685" y="111108"/>
            <a:ext cx="3757159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A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TIC INFORMATION PROCESSING </a:t>
            </a:r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E7629CDD-532F-E379-A0AE-C524EE72720C}"/>
              </a:ext>
            </a:extLst>
          </p:cNvPr>
          <p:cNvSpPr txBox="1"/>
          <p:nvPr/>
        </p:nvSpPr>
        <p:spPr>
          <a:xfrm>
            <a:off x="6931850" y="147474"/>
            <a:ext cx="4502589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A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NVIRONMENTAL INFORMATION PROCESSING 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D96C8450-9E6E-CC91-FFFC-4BF2D33A80E2}"/>
              </a:ext>
            </a:extLst>
          </p:cNvPr>
          <p:cNvSpPr txBox="1"/>
          <p:nvPr/>
        </p:nvSpPr>
        <p:spPr>
          <a:xfrm>
            <a:off x="2651529" y="3628434"/>
            <a:ext cx="2321469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A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ULAR PROCESSES </a:t>
            </a:r>
          </a:p>
        </p:txBody>
      </p:sp>
      <p:sp>
        <p:nvSpPr>
          <p:cNvPr id="34" name="Rectángulo 33">
            <a:extLst>
              <a:ext uri="{FF2B5EF4-FFF2-40B4-BE49-F238E27FC236}">
                <a16:creationId xmlns:a16="http://schemas.microsoft.com/office/drawing/2014/main" id="{6AF7FAD6-7FBF-1299-7F52-8339B60A4C30}"/>
              </a:ext>
            </a:extLst>
          </p:cNvPr>
          <p:cNvSpPr/>
          <p:nvPr/>
        </p:nvSpPr>
        <p:spPr>
          <a:xfrm>
            <a:off x="7854682" y="4639940"/>
            <a:ext cx="180000" cy="180000"/>
          </a:xfrm>
          <a:prstGeom prst="rect">
            <a:avLst/>
          </a:prstGeom>
          <a:solidFill>
            <a:srgbClr val="558ED5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AR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CuadroTexto 34">
            <a:extLst>
              <a:ext uri="{FF2B5EF4-FFF2-40B4-BE49-F238E27FC236}">
                <a16:creationId xmlns:a16="http://schemas.microsoft.com/office/drawing/2014/main" id="{6E525BD1-E016-16D3-8704-528E1F307864}"/>
              </a:ext>
            </a:extLst>
          </p:cNvPr>
          <p:cNvSpPr txBox="1"/>
          <p:nvPr/>
        </p:nvSpPr>
        <p:spPr>
          <a:xfrm>
            <a:off x="8034682" y="4609102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C1</a:t>
            </a:r>
          </a:p>
        </p:txBody>
      </p:sp>
      <p:sp>
        <p:nvSpPr>
          <p:cNvPr id="36" name="Rectángulo 35">
            <a:extLst>
              <a:ext uri="{FF2B5EF4-FFF2-40B4-BE49-F238E27FC236}">
                <a16:creationId xmlns:a16="http://schemas.microsoft.com/office/drawing/2014/main" id="{80F23A71-DAF6-772A-A92E-6521A3A771D6}"/>
              </a:ext>
            </a:extLst>
          </p:cNvPr>
          <p:cNvSpPr/>
          <p:nvPr/>
        </p:nvSpPr>
        <p:spPr>
          <a:xfrm>
            <a:off x="7854682" y="5052426"/>
            <a:ext cx="180000" cy="180000"/>
          </a:xfrm>
          <a:prstGeom prst="rect">
            <a:avLst/>
          </a:prstGeom>
          <a:solidFill>
            <a:srgbClr val="FFCC66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AR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CuadroTexto 36">
            <a:extLst>
              <a:ext uri="{FF2B5EF4-FFF2-40B4-BE49-F238E27FC236}">
                <a16:creationId xmlns:a16="http://schemas.microsoft.com/office/drawing/2014/main" id="{E3035216-5635-FF8B-AD63-15EED07E76AC}"/>
              </a:ext>
            </a:extLst>
          </p:cNvPr>
          <p:cNvSpPr txBox="1"/>
          <p:nvPr/>
        </p:nvSpPr>
        <p:spPr>
          <a:xfrm>
            <a:off x="8034682" y="5021588"/>
            <a:ext cx="8162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L1506</a:t>
            </a:r>
          </a:p>
        </p:txBody>
      </p:sp>
      <p:sp>
        <p:nvSpPr>
          <p:cNvPr id="38" name="Rectángulo 37">
            <a:extLst>
              <a:ext uri="{FF2B5EF4-FFF2-40B4-BE49-F238E27FC236}">
                <a16:creationId xmlns:a16="http://schemas.microsoft.com/office/drawing/2014/main" id="{D173C1A8-8596-01A4-360C-5807777F1AA4}"/>
              </a:ext>
            </a:extLst>
          </p:cNvPr>
          <p:cNvSpPr/>
          <p:nvPr/>
        </p:nvSpPr>
        <p:spPr>
          <a:xfrm>
            <a:off x="7854682" y="5451812"/>
            <a:ext cx="180000" cy="180000"/>
          </a:xfrm>
          <a:prstGeom prst="rect">
            <a:avLst/>
          </a:prstGeom>
          <a:solidFill>
            <a:srgbClr val="9D2269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AR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CuadroTexto 38">
            <a:extLst>
              <a:ext uri="{FF2B5EF4-FFF2-40B4-BE49-F238E27FC236}">
                <a16:creationId xmlns:a16="http://schemas.microsoft.com/office/drawing/2014/main" id="{9FD08C87-C056-9360-128A-9EE91016E0BD}"/>
              </a:ext>
            </a:extLst>
          </p:cNvPr>
          <p:cNvSpPr txBox="1"/>
          <p:nvPr/>
        </p:nvSpPr>
        <p:spPr>
          <a:xfrm>
            <a:off x="8034682" y="5420974"/>
            <a:ext cx="7056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CFS1</a:t>
            </a:r>
          </a:p>
        </p:txBody>
      </p:sp>
    </p:spTree>
    <p:extLst>
      <p:ext uri="{BB962C8B-B14F-4D97-AF65-F5344CB8AC3E}">
        <p14:creationId xmlns:p14="http://schemas.microsoft.com/office/powerpoint/2010/main" val="132642949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69</TotalTime>
  <Words>12</Words>
  <Application>Microsoft Office PowerPoint</Application>
  <PresentationFormat>Panorámica</PresentationFormat>
  <Paragraphs>6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eonardo Miguel</dc:creator>
  <cp:lastModifiedBy>Julio Villena</cp:lastModifiedBy>
  <cp:revision>44</cp:revision>
  <dcterms:created xsi:type="dcterms:W3CDTF">2021-05-19T11:31:25Z</dcterms:created>
  <dcterms:modified xsi:type="dcterms:W3CDTF">2022-08-29T11:31:53Z</dcterms:modified>
</cp:coreProperties>
</file>